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8" r:id="rId3"/>
    <p:sldId id="260" r:id="rId4"/>
    <p:sldId id="262" r:id="rId5"/>
    <p:sldId id="263" r:id="rId6"/>
    <p:sldId id="264" r:id="rId7"/>
    <p:sldId id="265" r:id="rId8"/>
    <p:sldId id="266" r:id="rId9"/>
    <p:sldId id="259" r:id="rId10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95" autoAdjust="0"/>
    <p:restoredTop sz="94660"/>
  </p:normalViewPr>
  <p:slideViewPr>
    <p:cSldViewPr snapToGrid="0">
      <p:cViewPr>
        <p:scale>
          <a:sx n="150" d="100"/>
          <a:sy n="150" d="100"/>
        </p:scale>
        <p:origin x="883" y="-47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141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92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035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22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365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07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8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52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171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682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345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90C48-0C3D-4C49-89B3-027FB4F35D77}" type="datetimeFigureOut">
              <a:rPr lang="zh-CN" altLang="en-US" smtClean="0"/>
              <a:t>2025/1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0641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6003" y="1875903"/>
            <a:ext cx="2889754" cy="324335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598620" y="5621774"/>
            <a:ext cx="50796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1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Quantitative analysis of glycine content in leaves of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. </a:t>
            </a:r>
            <a:r>
              <a:rPr lang="en-US" altLang="zh-CN" sz="1200" i="1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officinale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uring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ry treatment and rewetting phases. The glycine content increases during dry treatment and recovers during the rewetting phase.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7395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4665" y="1172586"/>
            <a:ext cx="3319328" cy="273600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469080" y="4021574"/>
            <a:ext cx="604460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2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Volcano plot depicting the distribution of DEGs between cold treatments and control conditions (CK)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Genes with a fold change (FC) greater than 2 and an adjusted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-value less than 0.05 are considered differentially expressed. </a:t>
            </a:r>
            <a:r>
              <a:rPr lang="en-US" altLang="zh-CN" sz="1200" kern="0" dirty="0" err="1" smtClean="0">
                <a:solidFill>
                  <a:srgbClr val="000000"/>
                </a:solidFill>
                <a:latin typeface="Times New Roman" panose="02020603050405020304" pitchFamily="18" charset="0"/>
              </a:rPr>
              <a:t>Upregulated</a:t>
            </a:r>
            <a:r>
              <a:rPr lang="en-US" altLang="zh-CN" sz="1200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genes are shown in red, </a:t>
            </a:r>
            <a:r>
              <a:rPr lang="en-US" altLang="zh-CN" sz="1200" kern="0" dirty="0" err="1" smtClean="0">
                <a:solidFill>
                  <a:srgbClr val="000000"/>
                </a:solidFill>
                <a:latin typeface="Times New Roman" panose="02020603050405020304" pitchFamily="18" charset="0"/>
              </a:rPr>
              <a:t>downregulated</a:t>
            </a:r>
            <a:r>
              <a:rPr lang="en-US" altLang="zh-CN" sz="1200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genes in blue, and non-significantly changed genes in black.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30912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4297" y="2018826"/>
            <a:ext cx="3178756" cy="2700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92315" y="5296371"/>
            <a:ext cx="546661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3. 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showing the expression patterns of the top 20 DEGs across different treatments. These genes are involved in multiple pathways, including secondary metabolism, carbohydrate metabolism, and stress response. The 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colors represent the relative expression levels of the genes, with warmer colors indicating higher expression and cooler colors indicating lower expression.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30186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73880" y="5759660"/>
            <a:ext cx="49721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4. The different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lipid species in CK, FT, and FR, providing a detailed view of the lipid composition changes under cold treatment.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4230" y="2180771"/>
            <a:ext cx="2340000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93358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9216" y="1490784"/>
            <a:ext cx="4894385" cy="3262923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554804" y="5297924"/>
            <a:ext cx="582341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5. The expression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levels of differentially alternatively spliced (DAS) genes involved in 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spliceosome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carbon metabolism, and amino acid metabolism across different treatments. The 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colors represent the relative expression levels of the genes, with warmer colors indicating higher expression and cooler colors indicating lower expression.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61658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31896" y="4344013"/>
            <a:ext cx="611515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6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he transcript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expression levels of three selected DAS genes (malate dehydrogenase, cysteine synthase, and zinc knuckle) across different treatments. 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446" y="1657252"/>
            <a:ext cx="2160000" cy="215544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1606" y="1653438"/>
            <a:ext cx="2160000" cy="2160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91606" y="1653438"/>
            <a:ext cx="2155443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01279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442" y="2025780"/>
            <a:ext cx="1722050" cy="240854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19862" y="2025780"/>
            <a:ext cx="1722050" cy="2408544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408952" y="4852013"/>
            <a:ext cx="594669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7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he transcript expression levels of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ADP-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ibosylation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factor and ATP binding actin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cross different treatments. 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  <a:p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70378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89185" y="978877"/>
            <a:ext cx="3960000" cy="3960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642549" y="5229756"/>
            <a:ext cx="56227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8. Th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expression levels of 324 splicing factor genes across different treatments. The </a:t>
            </a:r>
            <a:r>
              <a:rPr lang="en-US" altLang="zh-CN" sz="1200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heatma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colors represent the relative expression levels of the genes, with warmer colors indicating higher expression and cooler colors indicating lower expression.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435180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70914" y="7403811"/>
            <a:ext cx="529954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S9. </a:t>
            </a:r>
            <a:r>
              <a:rPr lang="en-US" altLang="zh-CN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Expression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rofiles of three genes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(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KU64802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XP_020672210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and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KU75555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)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related to ubiquitin proteins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in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various tissues of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. </a:t>
            </a:r>
            <a:r>
              <a:rPr lang="en-US" altLang="zh-CN" sz="1200" i="1" kern="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officinale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he expression levels are shown for different tissues, with leaves having the highest expression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altLang="zh-CN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b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Expression of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hree genes in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mature leaves of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lants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treated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with s-ODN (as control) and as-ODN during FT treatment. </a:t>
            </a:r>
            <a:r>
              <a:rPr lang="en-US" altLang="zh-CN" sz="1200" b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c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ca015217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ca012567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, and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Dca027386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expression treated with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KU64802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as-ODN during FT treatment.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Values are means ± S.D. (</a:t>
            </a:r>
            <a:r>
              <a:rPr lang="en-US" altLang="zh-CN" sz="1200" u="sng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n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= 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3). Student’s t‐test, * </a:t>
            </a:r>
            <a:r>
              <a:rPr lang="en-US" altLang="zh-CN" sz="1200" i="1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latin typeface="Times New Roman" panose="02020603050405020304" pitchFamily="18" charset="0"/>
              </a:rPr>
              <a:t> &lt; 0.05.</a:t>
            </a:r>
            <a:endParaRPr lang="zh-CN" altLang="en-US" sz="1200" kern="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68205" y="3303304"/>
            <a:ext cx="25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68205" y="352425"/>
            <a:ext cx="25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68205" y="5264704"/>
            <a:ext cx="25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205" y="369014"/>
            <a:ext cx="2420088" cy="2818691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205" y="3498533"/>
            <a:ext cx="2837887" cy="167023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4223" y="5500454"/>
            <a:ext cx="1125769" cy="1508606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9992" y="5500454"/>
            <a:ext cx="1121978" cy="1516187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42293" y="5479596"/>
            <a:ext cx="1125769" cy="1516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4031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26</TotalTime>
  <Words>433</Words>
  <Application>Microsoft Office PowerPoint</Application>
  <PresentationFormat>A4 纸张(210x297 毫米)</PresentationFormat>
  <Paragraphs>12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5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o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joe</cp:lastModifiedBy>
  <cp:revision>59</cp:revision>
  <dcterms:created xsi:type="dcterms:W3CDTF">2021-04-02T07:19:11Z</dcterms:created>
  <dcterms:modified xsi:type="dcterms:W3CDTF">2025-01-30T12:00:30Z</dcterms:modified>
</cp:coreProperties>
</file>